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724650" cy="97742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24"/>
    <p:restoredTop sz="94674"/>
  </p:normalViewPr>
  <p:slideViewPr>
    <p:cSldViewPr>
      <p:cViewPr varScale="1">
        <p:scale>
          <a:sx n="119" d="100"/>
          <a:sy n="119" d="100"/>
        </p:scale>
        <p:origin x="2136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615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0684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473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5374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9881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5236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4292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3170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1881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5062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8663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02307-E9CA-461D-99E3-7F4850AA464D}" type="datetimeFigureOut">
              <a:rPr lang="de-DE" smtClean="0"/>
              <a:t>26.06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35E9B-D551-43B6-AF22-6FE6B0474F4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548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dirty="0"/>
              <a:t>Papan et al.</a:t>
            </a:r>
            <a:endParaRPr lang="de-DE" sz="2400" dirty="0"/>
          </a:p>
          <a:p>
            <a:pPr marL="0" indent="0">
              <a:buNone/>
            </a:pPr>
            <a:r>
              <a:rPr lang="en-US" sz="2400" dirty="0"/>
              <a:t>Combined </a:t>
            </a:r>
            <a:r>
              <a:rPr lang="en-GB" sz="2400" dirty="0"/>
              <a:t>antibiotic</a:t>
            </a:r>
            <a:r>
              <a:rPr lang="en-US" sz="2400" dirty="0"/>
              <a:t> stewardship and infection control measures to contain the spread of linezolid-resistant </a:t>
            </a:r>
            <a:r>
              <a:rPr lang="en-US" sz="2400" i="1" dirty="0"/>
              <a:t>Staphylococcus epidermidis</a:t>
            </a:r>
            <a:r>
              <a:rPr lang="en-US" sz="2400" dirty="0"/>
              <a:t> in an intensive care unit</a:t>
            </a:r>
          </a:p>
          <a:p>
            <a:pPr marL="0" indent="0">
              <a:buNone/>
            </a:pPr>
            <a:endParaRPr lang="en-US" sz="2400" dirty="0"/>
          </a:p>
          <a:p>
            <a:pPr marL="0" indent="0">
              <a:buNone/>
            </a:pPr>
            <a:r>
              <a:rPr lang="en-US" sz="2400" dirty="0"/>
              <a:t>Supplementary Figure S1</a:t>
            </a:r>
          </a:p>
          <a:p>
            <a:pPr marL="0" indent="0">
              <a:buNone/>
            </a:pPr>
            <a:r>
              <a:rPr lang="en-US" sz="2400" dirty="0"/>
              <a:t>Figure legend:</a:t>
            </a:r>
          </a:p>
          <a:p>
            <a:pPr marL="0" indent="0">
              <a:buNone/>
            </a:pPr>
            <a:r>
              <a:rPr lang="en-US" sz="2400" dirty="0"/>
              <a:t>Pocket card on the use of antibiotics with Gram-positive coverage, provided during the antimicrobial stewardship intervention on an intensive care unit in southwest Germany, 2018-2020</a:t>
            </a:r>
            <a:endParaRPr lang="de-DE" sz="2400" dirty="0"/>
          </a:p>
          <a:p>
            <a:pPr marL="0" indent="0">
              <a:buNone/>
            </a:pPr>
            <a:endParaRPr lang="de-DE" sz="2400" dirty="0"/>
          </a:p>
        </p:txBody>
      </p:sp>
    </p:spTree>
    <p:extLst>
      <p:ext uri="{BB962C8B-B14F-4D97-AF65-F5344CB8AC3E}">
        <p14:creationId xmlns:p14="http://schemas.microsoft.com/office/powerpoint/2010/main" val="3747066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827584" y="188640"/>
            <a:ext cx="7632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ntibiotics</a:t>
            </a:r>
            <a:r>
              <a:rPr lang="de-DE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de-DE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with</a:t>
            </a:r>
            <a:r>
              <a:rPr lang="de-DE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de-DE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road</a:t>
            </a:r>
            <a:r>
              <a:rPr lang="de-DE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Gram-positive </a:t>
            </a:r>
            <a:r>
              <a:rPr lang="de-DE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overage</a:t>
            </a:r>
            <a:r>
              <a:rPr lang="de-DE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incl. MRSA, CONS, VRE)</a:t>
            </a:r>
          </a:p>
        </p:txBody>
      </p:sp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2301646"/>
              </p:ext>
            </p:extLst>
          </p:nvPr>
        </p:nvGraphicFramePr>
        <p:xfrm>
          <a:off x="179510" y="908720"/>
          <a:ext cx="8784980" cy="56514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841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281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322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32048">
                <a:tc>
                  <a:txBody>
                    <a:bodyPr/>
                    <a:lstStyle/>
                    <a:p>
                      <a:endParaRPr lang="de-DE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600" dirty="0" err="1"/>
                        <a:t>Vancomycin</a:t>
                      </a:r>
                      <a:endParaRPr lang="de-DE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600" dirty="0" err="1"/>
                        <a:t>Linezolid</a:t>
                      </a:r>
                      <a:endParaRPr lang="de-DE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600" dirty="0" err="1"/>
                        <a:t>Daptomycin</a:t>
                      </a:r>
                      <a:endParaRPr lang="de-DE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600"/>
                        <a:t>Tigecycline</a:t>
                      </a:r>
                      <a:endParaRPr lang="de-DE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04098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Dosing</a:t>
                      </a:r>
                      <a:r>
                        <a:rPr lang="de-DE" sz="1100" b="1" dirty="0"/>
                        <a:t> in </a:t>
                      </a:r>
                      <a:r>
                        <a:rPr lang="de-DE" sz="1100" b="1" dirty="0" err="1"/>
                        <a:t>adults</a:t>
                      </a:r>
                      <a:endParaRPr lang="de-DE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x 15 mg/kg BW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.v.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b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[in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ver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ection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art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gher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i.e. 20-25 mg/kg]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 x 600 m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.v.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.o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u="sng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wer</a:t>
                      </a:r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ose: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x 4 mg/k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.v.</a:t>
                      </a:r>
                      <a:endParaRPr lang="de-DE" sz="11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de-DE" sz="1100" u="sng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igher dose: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x 6-10 mg/k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.v.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0 m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adin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ose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n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50 m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er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12 h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ver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30-60 min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.v.</a:t>
                      </a:r>
                      <a:endParaRPr lang="de-DE" sz="11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endParaRPr lang="de-DE" sz="11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in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fe-threatenin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ection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: 200 m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adin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ose,</a:t>
                      </a:r>
                      <a:r>
                        <a:rPr lang="de-DE" sz="1100" kern="1200" baseline="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n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 x 100 mg)</a:t>
                      </a:r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28642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Therapeutic</a:t>
                      </a:r>
                      <a:r>
                        <a:rPr lang="de-DE" sz="1100" b="1" dirty="0"/>
                        <a:t> Drug Monitoring (TDM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u="sng" dirty="0"/>
                        <a:t>Target </a:t>
                      </a:r>
                      <a:r>
                        <a:rPr lang="de-DE" sz="1100" u="sng" dirty="0" err="1"/>
                        <a:t>trough</a:t>
                      </a:r>
                      <a:r>
                        <a:rPr lang="de-DE" sz="1100" u="sng" dirty="0"/>
                        <a:t> </a:t>
                      </a:r>
                      <a:r>
                        <a:rPr lang="de-DE" sz="1100" u="sng" dirty="0" err="1"/>
                        <a:t>levels</a:t>
                      </a:r>
                      <a:r>
                        <a:rPr lang="de-DE" sz="1100" u="sng" dirty="0"/>
                        <a:t>:</a:t>
                      </a:r>
                      <a:r>
                        <a:rPr lang="de-DE" sz="1100" dirty="0"/>
                        <a:t> (10-)15-20 mg/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u="sng" dirty="0"/>
                        <a:t>Target </a:t>
                      </a:r>
                      <a:r>
                        <a:rPr lang="de-DE" sz="1100" u="sng" dirty="0" err="1"/>
                        <a:t>range</a:t>
                      </a:r>
                      <a:r>
                        <a:rPr lang="de-DE" sz="1100" u="sng" dirty="0"/>
                        <a:t>:</a:t>
                      </a:r>
                      <a:r>
                        <a:rPr lang="de-DE" sz="1100" dirty="0"/>
                        <a:t> 6,5-12 mg/L </a:t>
                      </a:r>
                    </a:p>
                    <a:p>
                      <a:r>
                        <a:rPr lang="de-DE" sz="1100" dirty="0"/>
                        <a:t>(</a:t>
                      </a:r>
                      <a:r>
                        <a:rPr lang="de-DE" sz="1100" dirty="0" err="1"/>
                        <a:t>for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continuous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infusion</a:t>
                      </a:r>
                      <a:r>
                        <a:rPr lang="de-DE" sz="1100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/>
                        <a:t>Not </a:t>
                      </a:r>
                      <a:r>
                        <a:rPr lang="de-DE" sz="1100" dirty="0" err="1"/>
                        <a:t>available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/>
                        <a:t>Not </a:t>
                      </a:r>
                      <a:r>
                        <a:rPr lang="de-DE" sz="1100" dirty="0" err="1"/>
                        <a:t>available</a:t>
                      </a:r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20608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Misc</a:t>
                      </a:r>
                      <a:r>
                        <a:rPr lang="de-DE" sz="1100" b="1" dirty="0"/>
                        <a:t>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/>
                        <a:t>Infusion </a:t>
                      </a:r>
                      <a:r>
                        <a:rPr lang="de-DE" sz="1100" dirty="0" err="1"/>
                        <a:t>over</a:t>
                      </a:r>
                      <a:r>
                        <a:rPr lang="de-DE" sz="1100" dirty="0"/>
                        <a:t> at least 1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o not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mbin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ith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ifampicin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fficac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neumonia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es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well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ited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loodstream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ections</a:t>
                      </a:r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32048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Adverse</a:t>
                      </a:r>
                      <a:r>
                        <a:rPr lang="de-DE" sz="1100" b="1" dirty="0"/>
                        <a:t> </a:t>
                      </a:r>
                      <a:r>
                        <a:rPr lang="de-DE" sz="1100" b="1" dirty="0" err="1"/>
                        <a:t>reactions</a:t>
                      </a:r>
                      <a:endParaRPr lang="de-DE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fusion </a:t>
                      </a:r>
                      <a:r>
                        <a:rPr lang="de-DE" sz="11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action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phrotoxicit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totoxicit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rombophlebitis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yelosuppression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uropsychiatric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ent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rug-dru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eraction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ypertensiv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risi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erotonin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yndrom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habdomyolysis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onitor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CPK)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llergic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neumonitis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hotosensitivit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racranial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ypertension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creased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BUN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yperphosphatemia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patic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ailure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ancreatitis</a:t>
                      </a:r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04056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Contraindications</a:t>
                      </a:r>
                      <a:r>
                        <a:rPr lang="de-DE" sz="1100" b="1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Known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hypersensitivity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err="1"/>
                        <a:t>Known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hypersensitivity</a:t>
                      </a:r>
                      <a:r>
                        <a:rPr lang="de-DE" sz="1100" dirty="0"/>
                        <a:t>, MAO </a:t>
                      </a:r>
                      <a:r>
                        <a:rPr lang="de-DE" sz="1100" dirty="0" err="1"/>
                        <a:t>inhibitor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therapy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Known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hypersensitivity</a:t>
                      </a:r>
                      <a:endParaRPr lang="de-DE" sz="1100" dirty="0"/>
                    </a:p>
                    <a:p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Known</a:t>
                      </a:r>
                      <a:r>
                        <a:rPr lang="de-DE" sz="1100" dirty="0"/>
                        <a:t> </a:t>
                      </a:r>
                      <a:r>
                        <a:rPr lang="de-DE" sz="1100"/>
                        <a:t>hypersensitivity</a:t>
                      </a:r>
                      <a:endParaRPr lang="de-DE" sz="1100" dirty="0"/>
                    </a:p>
                    <a:p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35814">
                <a:tc>
                  <a:txBody>
                    <a:bodyPr/>
                    <a:lstStyle/>
                    <a:p>
                      <a:r>
                        <a:rPr lang="de-DE" sz="1100" b="1" dirty="0"/>
                        <a:t>Dose </a:t>
                      </a:r>
                      <a:r>
                        <a:rPr lang="de-DE" sz="1100" b="1" dirty="0" err="1"/>
                        <a:t>adjustment</a:t>
                      </a:r>
                      <a:r>
                        <a:rPr lang="de-DE" sz="1100" b="1" dirty="0"/>
                        <a:t> in renal </a:t>
                      </a:r>
                      <a:r>
                        <a:rPr lang="de-DE" sz="1100" b="1" dirty="0" err="1"/>
                        <a:t>failure</a:t>
                      </a:r>
                      <a:endParaRPr lang="de-DE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FR 10-50 ml/min: </a:t>
                      </a: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 mg/kg BW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er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4-96h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djust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ough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evel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b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FR &lt; 10 ml/min:</a:t>
                      </a:r>
                      <a:endParaRPr lang="de-DE" sz="1100" u="non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.5 mg/kg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every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48-72h </a:t>
                      </a:r>
                      <a:b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</a:b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djust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rough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evel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none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FR </a:t>
                      </a:r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  <a:sym typeface="Symbol"/>
                        </a:rPr>
                        <a:t></a:t>
                      </a:r>
                      <a:r>
                        <a:rPr lang="de-DE" sz="1100" u="sng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0 ml/min: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long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terval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om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4h </a:t>
                      </a:r>
                      <a:r>
                        <a:rPr lang="de-DE" sz="110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o</a:t>
                      </a:r>
                      <a:r>
                        <a:rPr lang="de-DE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48h</a:t>
                      </a:r>
                      <a:endParaRPr lang="de-DE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none</a:t>
                      </a:r>
                      <a:endParaRPr lang="de-DE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35814">
                <a:tc>
                  <a:txBody>
                    <a:bodyPr/>
                    <a:lstStyle/>
                    <a:p>
                      <a:r>
                        <a:rPr lang="de-DE" sz="1100" b="1" dirty="0" err="1"/>
                        <a:t>Induction</a:t>
                      </a:r>
                      <a:r>
                        <a:rPr lang="de-DE" sz="1100" b="1" dirty="0"/>
                        <a:t> </a:t>
                      </a:r>
                      <a:r>
                        <a:rPr lang="de-DE" sz="1100" b="1" dirty="0" err="1"/>
                        <a:t>of</a:t>
                      </a:r>
                      <a:r>
                        <a:rPr lang="de-DE" sz="1100" b="1" dirty="0"/>
                        <a:t> </a:t>
                      </a:r>
                      <a:r>
                        <a:rPr lang="de-DE" sz="1100" b="1" dirty="0" err="1"/>
                        <a:t>resistance</a:t>
                      </a:r>
                      <a:r>
                        <a:rPr lang="de-DE" sz="1100" b="1" dirty="0"/>
                        <a:t> in </a:t>
                      </a:r>
                      <a:r>
                        <a:rPr lang="de-DE" sz="1100" b="1" dirty="0" err="1"/>
                        <a:t>staphylococci</a:t>
                      </a:r>
                      <a:endParaRPr lang="de-DE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de-DE" sz="1100" dirty="0" err="1"/>
                        <a:t>Basically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none</a:t>
                      </a:r>
                      <a:endParaRPr lang="de-DE" sz="1100" dirty="0"/>
                    </a:p>
                  </a:txBody>
                  <a:tcP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/>
                        <a:t>+++</a:t>
                      </a:r>
                    </a:p>
                    <a:p>
                      <a:r>
                        <a:rPr lang="de-DE" sz="1100" dirty="0" err="1"/>
                        <a:t>Linezolid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resistance</a:t>
                      </a:r>
                      <a:endParaRPr lang="de-DE" sz="1100" dirty="0"/>
                    </a:p>
                  </a:txBody>
                  <a:tcP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/>
                        <a:t>+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err="1"/>
                        <a:t>Daptomycin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resistance</a:t>
                      </a:r>
                      <a:endParaRPr lang="de-DE" sz="110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/>
                        <a:t>+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dirty="0" err="1"/>
                        <a:t>Tigecycline</a:t>
                      </a:r>
                      <a:r>
                        <a:rPr lang="de-DE" sz="1100" dirty="0"/>
                        <a:t> </a:t>
                      </a:r>
                      <a:r>
                        <a:rPr lang="de-DE" sz="1100" dirty="0" err="1"/>
                        <a:t>resistance</a:t>
                      </a:r>
                      <a:endParaRPr lang="de-DE" sz="1100" dirty="0"/>
                    </a:p>
                  </a:txBody>
                  <a:tcP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1510211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9</Words>
  <Application>Microsoft Macintosh PowerPoint</Application>
  <PresentationFormat>Bildschirmpräsentation (4:3)</PresentationFormat>
  <Paragraphs>6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Verdana</vt:lpstr>
      <vt:lpstr>Larissa</vt:lpstr>
      <vt:lpstr>PowerPoint-Präsentation</vt:lpstr>
      <vt:lpstr>PowerPoint-Präsentation</vt:lpstr>
    </vt:vector>
  </TitlesOfParts>
  <Company>Universitätsklinikum des Saarland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cker, Sören</dc:creator>
  <cp:lastModifiedBy>Cihan Papan</cp:lastModifiedBy>
  <cp:revision>17</cp:revision>
  <cp:lastPrinted>2019-10-10T15:15:15Z</cp:lastPrinted>
  <dcterms:created xsi:type="dcterms:W3CDTF">2019-10-07T06:21:11Z</dcterms:created>
  <dcterms:modified xsi:type="dcterms:W3CDTF">2021-06-26T13:47:22Z</dcterms:modified>
</cp:coreProperties>
</file>